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57" r:id="rId3"/>
    <p:sldId id="256" r:id="rId4"/>
    <p:sldId id="259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091"/>
  </p:normalViewPr>
  <p:slideViewPr>
    <p:cSldViewPr snapToGrid="0">
      <p:cViewPr varScale="1">
        <p:scale>
          <a:sx n="94" d="100"/>
          <a:sy n="94" d="100"/>
        </p:scale>
        <p:origin x="73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71D2D02-2D51-EC23-DAF9-AD8B64A308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B397F625-C583-4B24-83CE-630109D3BD4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201565D-70E6-6698-AADE-ECE0FB7D79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FBE61-4497-BC4A-9C30-C6D408D972B9}" type="datetimeFigureOut">
              <a:rPr lang="fr-FR" smtClean="0"/>
              <a:t>02/1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62C96A7-5AA2-C97E-BD64-9B5F589FE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33688B7-6787-8C5A-6B3C-F1CE044E11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B9FE7-D50A-2B4A-BF8B-69520A582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77279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2C633AA-FAF5-52B9-BF05-F2659BC7B0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655D7ECB-6C9C-3D39-56A5-11008A70EC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35B0EBA-899B-6454-15D2-F2DAD01FD5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FBE61-4497-BC4A-9C30-C6D408D972B9}" type="datetimeFigureOut">
              <a:rPr lang="fr-FR" smtClean="0"/>
              <a:t>02/1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D75032B-2388-7BF5-F04F-37A4664317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C712350-382B-84D6-76E7-AA52B203CF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B9FE7-D50A-2B4A-BF8B-69520A582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8516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A2273BC5-D154-A7EE-9FE1-AA80F1A1E2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00B7128-AE9F-A2E0-11FF-1405EF789E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5A7B38C-CF39-9988-939F-477616C02E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FBE61-4497-BC4A-9C30-C6D408D972B9}" type="datetimeFigureOut">
              <a:rPr lang="fr-FR" smtClean="0"/>
              <a:t>02/1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9A9F6DC-C707-4D0F-2960-CCBA8BE967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3FBCE63-12D8-AE14-571B-7EACB65F5B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B9FE7-D50A-2B4A-BF8B-69520A582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2329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06A378A-B2AD-228F-874F-D7CF541CA5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8F6E412-2A34-57B6-9825-50F372FF81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7D84AF3-71DD-9450-96BF-BEEC15C4BA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FBE61-4497-BC4A-9C30-C6D408D972B9}" type="datetimeFigureOut">
              <a:rPr lang="fr-FR" smtClean="0"/>
              <a:t>02/1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81B1C20-C263-CDE9-80E4-B7A03935F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2C47625-67AF-944B-0D1B-59AA87701F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B9FE7-D50A-2B4A-BF8B-69520A582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19819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4D69464-68AF-543E-BA84-E179EDD522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3A18DF1-C904-1975-6C9A-AA121B7F97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6AFA958-3335-0F5C-A6E5-CDB4963298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FBE61-4497-BC4A-9C30-C6D408D972B9}" type="datetimeFigureOut">
              <a:rPr lang="fr-FR" smtClean="0"/>
              <a:t>02/1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F808B79-AFA3-D3ED-FFB9-84E3A0CB9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D266588-B079-C468-E736-4E50D9778C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B9FE7-D50A-2B4A-BF8B-69520A582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0708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CDAF29D-35FE-78E7-C16C-8935819E1B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A324C86-06AA-EE06-E8A3-2193F80AA8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F45516D-E98F-7C20-905C-D911B2DD7C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B60A775-C622-5F2B-55AC-B640CB0ED0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FBE61-4497-BC4A-9C30-C6D408D972B9}" type="datetimeFigureOut">
              <a:rPr lang="fr-FR" smtClean="0"/>
              <a:t>02/11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9832FE8-835F-DEC1-E697-54CF42E257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B2BF9CC-5E16-7338-9785-E39A9DF839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B9FE7-D50A-2B4A-BF8B-69520A582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3585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6E76FEB-6965-297E-871D-8D51E5656C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4D65BF2-E3C2-47FB-922D-5C732BAE6A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6994053-E17D-ED29-E874-0A2B611FB2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40BB6B32-9036-F883-4F9A-D257B47ED48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C1C2182-A772-9222-3678-9F248F1DA6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F2A20A6D-D65A-48B6-F7D6-F84DFA1B8B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FBE61-4497-BC4A-9C30-C6D408D972B9}" type="datetimeFigureOut">
              <a:rPr lang="fr-FR" smtClean="0"/>
              <a:t>02/11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659285D0-BCFE-DFC7-D206-E8CC121842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A6932A04-7E2A-E92A-9B14-D7348D0F35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B9FE7-D50A-2B4A-BF8B-69520A582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3360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0957210-6500-A9FD-2766-4E54049760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683B547-5F7A-3033-69FE-483A95D0E7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FBE61-4497-BC4A-9C30-C6D408D972B9}" type="datetimeFigureOut">
              <a:rPr lang="fr-FR" smtClean="0"/>
              <a:t>02/11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57BD60B-89B2-1417-428D-1A0BAE5988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F3ACD9B0-C7F7-880F-F548-56E4C1A6EE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B9FE7-D50A-2B4A-BF8B-69520A582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7526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6FED0F3-2317-E2DC-D3C0-FA5EA2EEC1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FBE61-4497-BC4A-9C30-C6D408D972B9}" type="datetimeFigureOut">
              <a:rPr lang="fr-FR" smtClean="0"/>
              <a:t>02/11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ED3C037B-B0C4-0803-7606-3A65DC718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4B498466-8A8E-26BB-AFA3-8C18E1C117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B9FE7-D50A-2B4A-BF8B-69520A582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07326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FE3A02D-DBB1-1EBE-E896-3E4E7144B4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984FC01-952E-F24F-7CF1-6E7EA919AC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C79DBE6-1065-4BA0-FADE-3F8373779E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1CDCFAD-A68C-A414-73F7-EC0EA7D51A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FBE61-4497-BC4A-9C30-C6D408D972B9}" type="datetimeFigureOut">
              <a:rPr lang="fr-FR" smtClean="0"/>
              <a:t>02/11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ACB1DE3-B0BB-47AB-4D02-FEBFF1317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3CD9B40-9479-842E-DA92-982ADECC4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B9FE7-D50A-2B4A-BF8B-69520A582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62045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F576001-56DF-0F5B-7107-AC1C517AA2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21CC607B-AE4A-EBE1-5D79-1152509220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EFF3851E-F054-ED0E-9236-F2073532AE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0372A68-8A81-7D8D-15EA-747DA2568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FBE61-4497-BC4A-9C30-C6D408D972B9}" type="datetimeFigureOut">
              <a:rPr lang="fr-FR" smtClean="0"/>
              <a:t>02/11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EA0BF3D-14DD-3ED9-9E15-99371DBB9B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385161D-2C83-AFB3-73CB-1BD1A23DEC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B9FE7-D50A-2B4A-BF8B-69520A582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94420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1AE818DB-A508-9B92-64A6-CECFE2AB7D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D2A304F-B6E8-FE2B-3A7F-A38899BACF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1764429-8F2E-97CB-8221-F9F4F66C3C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EFBE61-4497-BC4A-9C30-C6D408D972B9}" type="datetimeFigureOut">
              <a:rPr lang="fr-FR" smtClean="0"/>
              <a:t>02/1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492CB8E-A015-0D49-317F-D506041CFE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16BB28A-ED01-68D0-42A9-A70EEC0C35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7B9FE7-D50A-2B4A-BF8B-69520A5821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5692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5C39890-F8A5-B32F-96F0-444F7B6366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42916" y="2903608"/>
            <a:ext cx="10515600" cy="1325563"/>
          </a:xfrm>
        </p:spPr>
        <p:txBody>
          <a:bodyPr/>
          <a:lstStyle/>
          <a:p>
            <a:r>
              <a:rPr lang="fr-FR" dirty="0" err="1"/>
              <a:t>Supplementary</a:t>
            </a:r>
            <a:r>
              <a:rPr lang="fr-FR" dirty="0"/>
              <a:t> data 1: Original </a:t>
            </a:r>
            <a:r>
              <a:rPr lang="fr-FR" dirty="0" err="1"/>
              <a:t>pictures</a:t>
            </a:r>
            <a:r>
              <a:rPr lang="fr-FR" dirty="0"/>
              <a:t> </a:t>
            </a:r>
            <a:r>
              <a:rPr lang="fr-FR" dirty="0" err="1"/>
              <a:t>used</a:t>
            </a:r>
            <a:r>
              <a:rPr lang="fr-FR" dirty="0"/>
              <a:t> to </a:t>
            </a:r>
            <a:r>
              <a:rPr lang="fr-FR" dirty="0" err="1"/>
              <a:t>prepare</a:t>
            </a:r>
            <a:r>
              <a:rPr lang="fr-FR" dirty="0"/>
              <a:t> the Figure 6</a:t>
            </a:r>
          </a:p>
        </p:txBody>
      </p:sp>
    </p:spTree>
    <p:extLst>
      <p:ext uri="{BB962C8B-B14F-4D97-AF65-F5344CB8AC3E}">
        <p14:creationId xmlns:p14="http://schemas.microsoft.com/office/powerpoint/2010/main" val="26577902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Image 23">
            <a:extLst>
              <a:ext uri="{FF2B5EF4-FFF2-40B4-BE49-F238E27FC236}">
                <a16:creationId xmlns:a16="http://schemas.microsoft.com/office/drawing/2014/main" id="{D3E59FD7-3697-A21B-2D66-7D307085EF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1782041"/>
            <a:ext cx="7772400" cy="3293918"/>
          </a:xfrm>
          <a:prstGeom prst="rect">
            <a:avLst/>
          </a:prstGeom>
        </p:spPr>
      </p:pic>
      <p:sp>
        <p:nvSpPr>
          <p:cNvPr id="25" name="ZoneTexte 24">
            <a:extLst>
              <a:ext uri="{FF2B5EF4-FFF2-40B4-BE49-F238E27FC236}">
                <a16:creationId xmlns:a16="http://schemas.microsoft.com/office/drawing/2014/main" id="{7E7C7847-11D5-8B3E-2E04-04530E56FB68}"/>
              </a:ext>
            </a:extLst>
          </p:cNvPr>
          <p:cNvSpPr txBox="1"/>
          <p:nvPr/>
        </p:nvSpPr>
        <p:spPr>
          <a:xfrm>
            <a:off x="1676400" y="5401733"/>
            <a:ext cx="96689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Original gel image for the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onfirmation of positive transgenic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rabidopsis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lines by PCR</a:t>
            </a:r>
            <a:r>
              <a:rPr lang="fr-FR" sz="1800" dirty="0">
                <a:solidFill>
                  <a:srgbClr val="000000"/>
                </a:solidFill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fr-FR" sz="1800" dirty="0" err="1">
                <a:solidFill>
                  <a:srgbClr val="000000"/>
                </a:solidFill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lease</a:t>
            </a:r>
            <a:r>
              <a:rPr lang="fr-FR" sz="1800" dirty="0">
                <a:solidFill>
                  <a:srgbClr val="000000"/>
                </a:solidFill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fr-FR" sz="1800" dirty="0" err="1">
                <a:solidFill>
                  <a:srgbClr val="000000"/>
                </a:solidFill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refer</a:t>
            </a:r>
            <a:r>
              <a:rPr lang="fr-FR" sz="1800" dirty="0">
                <a:solidFill>
                  <a:srgbClr val="000000"/>
                </a:solidFill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to the Figure 6 for </a:t>
            </a:r>
            <a:r>
              <a:rPr lang="fr-FR" sz="1800" dirty="0" err="1">
                <a:solidFill>
                  <a:srgbClr val="000000"/>
                </a:solidFill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etails</a:t>
            </a:r>
            <a:r>
              <a:rPr lang="fr-FR" sz="1800" dirty="0">
                <a:solidFill>
                  <a:srgbClr val="000000"/>
                </a:solidFill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The 11 first </a:t>
            </a:r>
            <a:r>
              <a:rPr lang="fr-FR" sz="1800" dirty="0" err="1">
                <a:solidFill>
                  <a:srgbClr val="000000"/>
                </a:solidFill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ransgenic</a:t>
            </a:r>
            <a:r>
              <a:rPr lang="fr-FR" sz="1800" dirty="0">
                <a:solidFill>
                  <a:srgbClr val="000000"/>
                </a:solidFill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plants </a:t>
            </a:r>
            <a:r>
              <a:rPr lang="fr-FR" sz="1800" dirty="0" err="1">
                <a:solidFill>
                  <a:srgbClr val="000000"/>
                </a:solidFill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were</a:t>
            </a:r>
            <a:r>
              <a:rPr lang="fr-FR" sz="1800" dirty="0">
                <a:solidFill>
                  <a:srgbClr val="000000"/>
                </a:solidFill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fr-FR" sz="1800" dirty="0" err="1">
                <a:solidFill>
                  <a:srgbClr val="000000"/>
                </a:solidFill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kept</a:t>
            </a:r>
            <a:r>
              <a:rPr lang="fr-FR" sz="1800" dirty="0">
                <a:solidFill>
                  <a:srgbClr val="000000"/>
                </a:solidFill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in </a:t>
            </a:r>
            <a:r>
              <a:rPr lang="fr-FR" sz="1800" dirty="0" err="1">
                <a:solidFill>
                  <a:srgbClr val="000000"/>
                </a:solidFill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his</a:t>
            </a:r>
            <a:r>
              <a:rPr lang="fr-FR" sz="1800" dirty="0">
                <a:solidFill>
                  <a:srgbClr val="000000"/>
                </a:solidFill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fr-FR" sz="1800" dirty="0" err="1">
                <a:solidFill>
                  <a:srgbClr val="000000"/>
                </a:solidFill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tudy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877245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zh-CN" altLang="en-US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22363"/>
            <a:ext cx="5825066" cy="32765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7A48E64F-4ADC-3108-041D-C52A81C82E13}"/>
              </a:ext>
            </a:extLst>
          </p:cNvPr>
          <p:cNvSpPr txBox="1"/>
          <p:nvPr/>
        </p:nvSpPr>
        <p:spPr>
          <a:xfrm>
            <a:off x="2523067" y="4623262"/>
            <a:ext cx="96689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Original </a:t>
            </a:r>
            <a:r>
              <a:rPr lang="fr-FR" dirty="0" err="1"/>
              <a:t>pictures</a:t>
            </a:r>
            <a:r>
              <a:rPr lang="fr-FR" dirty="0"/>
              <a:t> for the </a:t>
            </a:r>
            <a:r>
              <a:rPr lang="fr-FR" dirty="0" err="1"/>
              <a:t>selection</a:t>
            </a:r>
            <a:r>
              <a:rPr lang="fr-FR" dirty="0"/>
              <a:t> of the positive transformants </a:t>
            </a:r>
          </a:p>
        </p:txBody>
      </p:sp>
      <p:pic>
        <p:nvPicPr>
          <p:cNvPr id="5" name="Picture 2">
            <a:extLst>
              <a:ext uri="{FF2B5EF4-FFF2-40B4-BE49-F238E27FC236}">
                <a16:creationId xmlns:a16="http://schemas.microsoft.com/office/drawing/2014/main" id="{18131194-5744-D65E-4A4D-F62D530BA59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0" y="1120801"/>
            <a:ext cx="5824940" cy="32765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0204132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2F707DFE-AA1A-7C2B-5B4B-767BA99C3D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-127000" y="851798"/>
            <a:ext cx="6858000" cy="5137470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081D7A83-70E1-A9FB-0E0B-09BE9B07A5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6510867" y="860265"/>
            <a:ext cx="6858000" cy="5137470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6CE7779A-A939-2451-BF31-A6D5B698EC30}"/>
              </a:ext>
            </a:extLst>
          </p:cNvPr>
          <p:cNvSpPr txBox="1"/>
          <p:nvPr/>
        </p:nvSpPr>
        <p:spPr>
          <a:xfrm>
            <a:off x="1385201" y="6045661"/>
            <a:ext cx="112470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solidFill>
                  <a:schemeClr val="bg1"/>
                </a:solidFill>
              </a:rPr>
              <a:t>Original </a:t>
            </a:r>
            <a:r>
              <a:rPr lang="fr-FR" dirty="0" err="1">
                <a:solidFill>
                  <a:schemeClr val="bg1"/>
                </a:solidFill>
              </a:rPr>
              <a:t>pictures</a:t>
            </a:r>
            <a:r>
              <a:rPr lang="fr-FR" dirty="0">
                <a:solidFill>
                  <a:schemeClr val="bg1"/>
                </a:solidFill>
              </a:rPr>
              <a:t> for the </a:t>
            </a:r>
            <a:r>
              <a:rPr lang="en-US" dirty="0">
                <a:solidFill>
                  <a:schemeClr val="bg1"/>
                </a:solidFill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chemeClr val="bg1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omparison of wild type and transgenic </a:t>
            </a:r>
            <a:r>
              <a:rPr lang="en-US" sz="1800" i="1" dirty="0">
                <a:solidFill>
                  <a:schemeClr val="bg1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abidopsis</a:t>
            </a:r>
            <a:r>
              <a:rPr lang="en-US" sz="1800" dirty="0">
                <a:solidFill>
                  <a:schemeClr val="bg1"/>
                </a:solidFill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seedlings under salt stress conditions (100 mM NaCl) for seven days</a:t>
            </a:r>
            <a:r>
              <a:rPr lang="fr-FR" dirty="0">
                <a:solidFill>
                  <a:schemeClr val="bg1"/>
                </a:solidFill>
                <a:effectLst/>
              </a:rPr>
              <a:t> </a:t>
            </a:r>
            <a:endParaRPr lang="fr-FR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0175505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78</Words>
  <Application>Microsoft Macintosh PowerPoint</Application>
  <PresentationFormat>Grand écran</PresentationFormat>
  <Paragraphs>4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Thème Office</vt:lpstr>
      <vt:lpstr>Supplementary data 1: Original pictures used to prepare the Figure 6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office</dc:creator>
  <cp:lastModifiedBy>office</cp:lastModifiedBy>
  <cp:revision>4</cp:revision>
  <dcterms:created xsi:type="dcterms:W3CDTF">2022-09-22T07:58:52Z</dcterms:created>
  <dcterms:modified xsi:type="dcterms:W3CDTF">2022-11-02T18:08:46Z</dcterms:modified>
</cp:coreProperties>
</file>